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5A9F937-45EB-B44D-984A-57074389ADD2}" v="2" dt="2024-01-12T12:16:29.285"/>
    <p1510:client id="{F6FB32E6-F912-C242-8F3D-17E71D9B1660}" v="1" dt="2024-01-12T11:56:02.08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126" d="100"/>
          <a:sy n="126" d="100"/>
        </p:scale>
        <p:origin x="32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12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microsoft.com/office/2016/11/relationships/changesInfo" Target="changesInfos/changesInfo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Qi PAN (20567662)" userId="bcbb93bd-4ab9-4583-a92c-85cf909a14d6" providerId="ADAL" clId="{F6FB32E6-F912-C242-8F3D-17E71D9B1660}"/>
    <pc:docChg chg="custSel modSld">
      <pc:chgData name="Qi PAN (20567662)" userId="bcbb93bd-4ab9-4583-a92c-85cf909a14d6" providerId="ADAL" clId="{F6FB32E6-F912-C242-8F3D-17E71D9B1660}" dt="2024-01-12T11:56:09.701" v="5" actId="1076"/>
      <pc:docMkLst>
        <pc:docMk/>
      </pc:docMkLst>
      <pc:sldChg chg="addSp delSp modSp mod">
        <pc:chgData name="Qi PAN (20567662)" userId="bcbb93bd-4ab9-4583-a92c-85cf909a14d6" providerId="ADAL" clId="{F6FB32E6-F912-C242-8F3D-17E71D9B1660}" dt="2024-01-12T11:56:09.701" v="5" actId="1076"/>
        <pc:sldMkLst>
          <pc:docMk/>
          <pc:sldMk cId="2533011358" sldId="256"/>
        </pc:sldMkLst>
        <pc:picChg chg="add mod">
          <ac:chgData name="Qi PAN (20567662)" userId="bcbb93bd-4ab9-4583-a92c-85cf909a14d6" providerId="ADAL" clId="{F6FB32E6-F912-C242-8F3D-17E71D9B1660}" dt="2024-01-12T11:56:09.701" v="5" actId="1076"/>
          <ac:picMkLst>
            <pc:docMk/>
            <pc:sldMk cId="2533011358" sldId="256"/>
            <ac:picMk id="3" creationId="{C18A8153-07CC-CB2C-4415-82D9DF97250E}"/>
          </ac:picMkLst>
        </pc:picChg>
        <pc:picChg chg="del">
          <ac:chgData name="Qi PAN (20567662)" userId="bcbb93bd-4ab9-4583-a92c-85cf909a14d6" providerId="ADAL" clId="{F6FB32E6-F912-C242-8F3D-17E71D9B1660}" dt="2024-01-12T11:55:59.495" v="0" actId="478"/>
          <ac:picMkLst>
            <pc:docMk/>
            <pc:sldMk cId="2533011358" sldId="256"/>
            <ac:picMk id="5" creationId="{11CDB4D8-691A-A995-950A-437C7D02FCBB}"/>
          </ac:picMkLst>
        </pc:picChg>
      </pc:sldChg>
    </pc:docChg>
  </pc:docChgLst>
  <pc:docChgLst>
    <pc:chgData name="Qi PAN (20567662)" userId="bcbb93bd-4ab9-4583-a92c-85cf909a14d6" providerId="ADAL" clId="{95A9F937-45EB-B44D-984A-57074389ADD2}"/>
    <pc:docChg chg="custSel modSld">
      <pc:chgData name="Qi PAN (20567662)" userId="bcbb93bd-4ab9-4583-a92c-85cf909a14d6" providerId="ADAL" clId="{95A9F937-45EB-B44D-984A-57074389ADD2}" dt="2024-01-12T12:16:53.280" v="18" actId="1076"/>
      <pc:docMkLst>
        <pc:docMk/>
      </pc:docMkLst>
      <pc:sldChg chg="addSp delSp modSp mod">
        <pc:chgData name="Qi PAN (20567662)" userId="bcbb93bd-4ab9-4583-a92c-85cf909a14d6" providerId="ADAL" clId="{95A9F937-45EB-B44D-984A-57074389ADD2}" dt="2024-01-12T12:16:53.280" v="18" actId="1076"/>
        <pc:sldMkLst>
          <pc:docMk/>
          <pc:sldMk cId="2533011358" sldId="256"/>
        </pc:sldMkLst>
        <pc:spChg chg="add mod">
          <ac:chgData name="Qi PAN (20567662)" userId="bcbb93bd-4ab9-4583-a92c-85cf909a14d6" providerId="ADAL" clId="{95A9F937-45EB-B44D-984A-57074389ADD2}" dt="2024-01-12T12:16:53.280" v="18" actId="1076"/>
          <ac:spMkLst>
            <pc:docMk/>
            <pc:sldMk cId="2533011358" sldId="256"/>
            <ac:spMk id="5" creationId="{DADF1A3D-5AC1-CF99-678E-CBE7A119F193}"/>
          </ac:spMkLst>
        </pc:spChg>
        <pc:picChg chg="del">
          <ac:chgData name="Qi PAN (20567662)" userId="bcbb93bd-4ab9-4583-a92c-85cf909a14d6" providerId="ADAL" clId="{95A9F937-45EB-B44D-984A-57074389ADD2}" dt="2024-01-12T12:16:07.027" v="0" actId="478"/>
          <ac:picMkLst>
            <pc:docMk/>
            <pc:sldMk cId="2533011358" sldId="256"/>
            <ac:picMk id="3" creationId="{C18A8153-07CC-CB2C-4415-82D9DF97250E}"/>
          </ac:picMkLst>
        </pc:picChg>
        <pc:picChg chg="add mod">
          <ac:chgData name="Qi PAN (20567662)" userId="bcbb93bd-4ab9-4583-a92c-85cf909a14d6" providerId="ADAL" clId="{95A9F937-45EB-B44D-984A-57074389ADD2}" dt="2024-01-12T12:16:28.427" v="7" actId="1076"/>
          <ac:picMkLst>
            <pc:docMk/>
            <pc:sldMk cId="2533011358" sldId="256"/>
            <ac:picMk id="4" creationId="{30D6EE31-3C12-DE9D-18C4-915D09190F6E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75DE37-DAB8-524A-36CE-1F562359EA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2227BDA-50A8-02E3-9C62-B89E3720EFC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EAE99A-E347-8CED-CC4F-F23F7D5ADF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D5417AC-7E91-1791-FB35-B12E174812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7C00D39-797D-920A-780E-86962487EB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99370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BA6F028-A2D6-CAAE-B01E-6F9D86C2B5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9FC735B-3A6B-3BD8-83D7-8EE0E51A569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0CDAB94-5493-FAFF-FE7A-6C2DADD7D8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336C8A1-EA51-787D-5869-00704B267AA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2B64E8-C9A8-FFF3-2A70-198F5869D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56578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5DC3CFE-78B5-822E-7110-AB13E3CAA3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6934B1FF-A3EB-F259-1F18-5BA208A8461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F72761-F59D-E592-D7F4-93CFA5F1F4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998B963-DB60-4D4C-7D72-115CCA333E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42A720C-79F0-6617-C76B-9D3FD47111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17715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8E59864-36AB-0B12-F17F-E00E98B298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7794DE2-740E-638F-F417-BD95C11B504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88DD750-029A-DF56-2489-2AE6AB769E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6D0A24-B7ED-0BB4-75E5-75EE2CE413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DB41BC5-6D2E-6C4B-1973-A378C3F4C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07074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2963ED-E577-B192-2186-2BA719E393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5AA342B-5D57-A3AA-EDB3-5074CBFA40A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E9D6DBC-C01A-8EB0-3AEB-163731B6C4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9A19EF-765B-AA1B-B984-94053B0B65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4888D3D-AB20-1C40-52F8-CBEF0A45B3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97558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6DCBAED-E3E4-ED56-4DC3-25B6641302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DE79B8D-7A21-E232-0396-FB92ED45E4D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4CBE58E5-3F41-AACF-F07B-1DFC8C9C09E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8243D13-DC3F-9BCF-06AE-FA0973994D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2791BCD-AD75-6BF9-7B38-60FC89116E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AD156C0-FBE9-45D7-1C7D-E34576DEA7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991887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55ECCE-25A2-C4A1-CFC0-EEB68A3EADE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231AF53-E7AF-61A2-BC88-CB69F18124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ED48E305-08E4-26B5-8103-5E6D4D0830F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C8F03C23-3682-F820-9014-C9E3BF8D9D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BF98E60-F718-0062-2164-22EFE04CAB6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A350F3D-8BDE-2FF5-39DC-A394F0CE61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3949AC5-9685-53AD-6042-083D15AD3A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792F02D5-5985-E9CF-937D-B4DDE7EA5C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655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43B95C7-DF33-F499-0655-5631B4A61FB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DC79ABC-95AB-06A5-2F16-4AAD95DC83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BE7D470-6C20-F89D-CD2F-F4DF2F8AC4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3371AB3-B251-1A96-2928-BE5E857340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62274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D713F258-4F81-CDC7-5235-44EB1FB7EA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D432ED2-32D0-77DE-43CA-ECF6F7AE20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D1A4048-829B-F19F-7A4C-B15332F78E0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719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A2BAC1-58DA-C371-ECA9-9463D6BD30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BEC84DD-276D-9989-14E1-9B0F6A847AD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CA21B89A-DEA1-C529-8231-242D7F339C9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59A8B0EE-6A4F-9CB8-5240-57797DF03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08B5ECE-EBAC-80A3-2C8D-862198511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B7EC5A5-2365-957D-E501-A55D3117D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781426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72969AF-6949-52F3-6720-C45C0E00CC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8C38E1B7-2E58-B481-3D60-EE19E0BA84D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1A0364A-44C5-129E-63F6-9486B2B0053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62451A6-382A-FE67-4B60-DB6EC9775F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7F9F63F-74A5-F4E9-0FA1-EA7F430F37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4EC29F02-4977-BED6-652A-9B4457F7E4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4915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C3BFC56-3306-42DF-9593-8A63D2B69C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73064B6-ECAF-592E-ECEB-1EEFB914715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1E109A8-FA92-CA31-1C35-AFFBAFD66CB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5E9BF3-2A24-4369-B2C5-666C8D80FF10}" type="datetimeFigureOut">
              <a:rPr lang="zh-CN" altLang="en-US" smtClean="0"/>
              <a:t>2024/2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F0F29F-0353-A97D-4E01-C099B4F9791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7621E45-031D-1655-5AA7-E5A8504209F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E4B08-0C86-4ADE-B2EA-2B30FD2296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26649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DF1A3D-5AC1-CF99-678E-CBE7A119F193}"/>
              </a:ext>
            </a:extLst>
          </p:cNvPr>
          <p:cNvSpPr txBox="1"/>
          <p:nvPr/>
        </p:nvSpPr>
        <p:spPr>
          <a:xfrm>
            <a:off x="4535315" y="6199632"/>
            <a:ext cx="3121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kern="0" dirty="0" err="1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PheWAS</a:t>
            </a:r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 of Gene SLC39A8 </a:t>
            </a:r>
            <a:endParaRPr kumimoji="1" lang="zh-CN" altLang="en-US" dirty="0"/>
          </a:p>
        </p:txBody>
      </p:sp>
      <p:pic>
        <p:nvPicPr>
          <p:cNvPr id="2" name="图片 1">
            <a:extLst>
              <a:ext uri="{FF2B5EF4-FFF2-40B4-BE49-F238E27FC236}">
                <a16:creationId xmlns:a16="http://schemas.microsoft.com/office/drawing/2014/main" id="{187417DA-2FEA-970E-20C3-EAA26FCEA5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5618" y="1860749"/>
            <a:ext cx="11020763" cy="313650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30113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DF1A3D-5AC1-CF99-678E-CBE7A119F193}"/>
              </a:ext>
            </a:extLst>
          </p:cNvPr>
          <p:cNvSpPr txBox="1"/>
          <p:nvPr/>
        </p:nvSpPr>
        <p:spPr>
          <a:xfrm>
            <a:off x="4535315" y="6199632"/>
            <a:ext cx="28905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kern="0" dirty="0" err="1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PheWAS</a:t>
            </a:r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 of Gene FOXP2 </a:t>
            </a:r>
            <a:endParaRPr kumimoji="1"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D9FF8D5-4807-F70D-6C04-E808907817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05852" y="1838047"/>
            <a:ext cx="11180296" cy="31819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9321287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DF1A3D-5AC1-CF99-678E-CBE7A119F193}"/>
              </a:ext>
            </a:extLst>
          </p:cNvPr>
          <p:cNvSpPr txBox="1"/>
          <p:nvPr/>
        </p:nvSpPr>
        <p:spPr>
          <a:xfrm>
            <a:off x="4535315" y="6199632"/>
            <a:ext cx="27366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kern="0" dirty="0" err="1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PheWAS</a:t>
            </a:r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 of Gene DCF5 </a:t>
            </a:r>
            <a:endParaRPr kumimoji="1"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D851DB20-23FD-EF86-48D9-C885A422C6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2750" y="1766015"/>
            <a:ext cx="11686499" cy="33259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506747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DF1A3D-5AC1-CF99-678E-CBE7A119F193}"/>
              </a:ext>
            </a:extLst>
          </p:cNvPr>
          <p:cNvSpPr txBox="1"/>
          <p:nvPr/>
        </p:nvSpPr>
        <p:spPr>
          <a:xfrm>
            <a:off x="4535315" y="6199632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kern="0" dirty="0" err="1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PheWAS</a:t>
            </a:r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 of Gene CA10 </a:t>
            </a:r>
            <a:endParaRPr kumimoji="1"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E71FDF9-5C5C-31DD-4E54-D7290F8CF7B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24149" y="1786335"/>
            <a:ext cx="11543702" cy="328533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501273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DADF1A3D-5AC1-CF99-678E-CBE7A119F193}"/>
              </a:ext>
            </a:extLst>
          </p:cNvPr>
          <p:cNvSpPr txBox="1"/>
          <p:nvPr/>
        </p:nvSpPr>
        <p:spPr>
          <a:xfrm>
            <a:off x="4535315" y="6199632"/>
            <a:ext cx="2710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kern="0" dirty="0" err="1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PheWAS</a:t>
            </a:r>
            <a:r>
              <a:rPr lang="en-US" altLang="zh-CN" kern="0" dirty="0">
                <a:solidFill>
                  <a:srgbClr val="000000"/>
                </a:solidFill>
                <a:latin typeface="Arial" panose="020B0604020202020204" pitchFamily="34" charset="0"/>
                <a:ea typeface="DengXian" panose="02010600030101010101" pitchFamily="2" charset="-122"/>
              </a:rPr>
              <a:t> of Gene TCF4 </a:t>
            </a:r>
            <a:endParaRPr kumimoji="1"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4AA5BE46-FD9D-2EE7-3601-999E1D8F328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06285" y="1752791"/>
            <a:ext cx="11779429" cy="33524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22231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20</Words>
  <Application>Microsoft Macintosh PowerPoint</Application>
  <PresentationFormat>宽屏</PresentationFormat>
  <Paragraphs>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9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eihua.meng</dc:creator>
  <cp:lastModifiedBy>Pan, Qi</cp:lastModifiedBy>
  <cp:revision>3</cp:revision>
  <dcterms:created xsi:type="dcterms:W3CDTF">2022-08-21T00:56:49Z</dcterms:created>
  <dcterms:modified xsi:type="dcterms:W3CDTF">2024-02-17T07:55:30Z</dcterms:modified>
</cp:coreProperties>
</file>